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F45F9-D967-4443-BFAA-E6A12EAAB3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D3AE5-C867-4108-ACE8-9143AB8824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2F9B8-E51C-44CE-8D52-502EC0AB0A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CB23F-4452-452C-A49D-B87C1FA42C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EB019-4154-4D07-B4E9-A1212BF2C5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F60B7-E37B-4012-8F65-F8C5E0E2B3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C849BF-2282-466E-B3F9-6C12975FD5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DE57D-BEF0-4DC4-BB0B-A515CAE34F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D9FF2-A3DF-45E7-B9C1-A70211A81C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296B8-8C9B-4043-B71D-732BBAC3A3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FCB24-AFC2-4650-957A-80D8F0CF6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C2B83-D081-45E5-A93E-3F994ADA99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1C0213-00AC-4CAA-930C-F52CA2778FA0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Diagramm 3" descr=""/>
          <p:cNvPicPr/>
          <p:nvPr/>
        </p:nvPicPr>
        <p:blipFill>
          <a:blip r:embed="rId1"/>
          <a:stretch/>
        </p:blipFill>
        <p:spPr>
          <a:xfrm>
            <a:off x="3657600" y="857160"/>
            <a:ext cx="5440320" cy="28447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395280" y="1168560"/>
          <a:ext cx="3324240" cy="4574880"/>
        </p:xfrm>
        <a:graphic>
          <a:graphicData uri="http://schemas.openxmlformats.org/drawingml/2006/table">
            <a:tbl>
              <a:tblPr/>
              <a:tblGrid>
                <a:gridCol w="2255760"/>
                <a:gridCol w="466920"/>
                <a:gridCol w="601560"/>
              </a:tblGrid>
              <a:tr h="31572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Demographic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Mean age, years; (range)</a:t>
                      </a:r>
                      <a:r>
                        <a:rPr b="0" lang="en-US" sz="9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9.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41-9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Gender, n female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5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Median pre-mRS; (rang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0-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Diagno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Ischemic stroke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90.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Intracerebral hemorrhage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9.9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7448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troke severit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IHSS at admission, median; (rang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3-28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ou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uccessful CPR on Stroke Unit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36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3216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Days to death, median; (rang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Death expected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Death unexpected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0-26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81.8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18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3000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dvance direc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Living will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Power of attorney for health care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Legal guardian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13.6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18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36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946080"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use of deat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omplication of stroke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rdiac disorder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evere infection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Other/not known, n;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760" rIns="50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45.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27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4.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22.7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760" marR="50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feld 6"/>
          <p:cNvSpPr/>
          <p:nvPr/>
        </p:nvSpPr>
        <p:spPr>
          <a:xfrm>
            <a:off x="3851280" y="3716280"/>
            <a:ext cx="529272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alibri"/>
                <a:ea typeface="Arial"/>
              </a:rPr>
              <a:t>Abbreviations: NIHSS, National Institute of Health Stroke Scale; CPR, cardiopulmonary resuscitation; RASS, Richmond Agitation Sedation Scale; TL, therapeutic limitation; DNRO, do-not-resuscitate order; MV, mechanical ventila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r>
              <a:rPr b="0" lang="de-DE" sz="1000" spc="-1" strike="noStrike">
                <a:solidFill>
                  <a:srgbClr val="000000"/>
                </a:solidFill>
                <a:latin typeface="Calibri"/>
                <a:ea typeface="Arial"/>
              </a:rPr>
              <a:t>: Exclusion of 1 patient due to insufficient document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0" lang="de-DE" sz="1000" spc="-1" strike="noStrike">
                <a:solidFill>
                  <a:srgbClr val="000000"/>
                </a:solidFill>
                <a:latin typeface="Calibri"/>
                <a:ea typeface="Arial"/>
              </a:rPr>
              <a:t>: Dying patients transferred to Intensive Care Unit were significantly younger than patients dying on Stroke Unit (n=117) (p=0.0005, two-sided Student‘s t-test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r>
              <a:rPr b="0" lang="de-DE" sz="1000" spc="-1" strike="noStrike">
                <a:solidFill>
                  <a:srgbClr val="000000"/>
                </a:solidFill>
                <a:latin typeface="Calibri"/>
                <a:ea typeface="Arial"/>
              </a:rPr>
              <a:t>: In 6/22 patients (27.3%), the decision to withdraw or withhold therapeutic measures was made by the treating physicians due to lack of a persisting medical indica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feld 7"/>
          <p:cNvSpPr/>
          <p:nvPr/>
        </p:nvSpPr>
        <p:spPr>
          <a:xfrm>
            <a:off x="324000" y="189000"/>
            <a:ext cx="338436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Additional file 1: Figure S1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Calibri"/>
                <a:ea typeface="Arial"/>
              </a:rPr>
              <a:t>a. </a:t>
            </a: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Baseline characteristics and demographic information of patients transferred to Intensive Care Unit (n=22)</a:t>
            </a:r>
            <a:r>
              <a:rPr b="1" lang="en-US" sz="11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8"/>
          <p:cNvSpPr/>
          <p:nvPr/>
        </p:nvSpPr>
        <p:spPr>
          <a:xfrm>
            <a:off x="3602520" y="360360"/>
            <a:ext cx="564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Calibri"/>
                <a:ea typeface="Arial"/>
              </a:rPr>
              <a:t>b. End-of-life decisions</a:t>
            </a:r>
            <a:r>
              <a:rPr b="1" lang="de-DE" sz="11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r>
              <a:rPr b="1" lang="de-DE" sz="1100" spc="-1" strike="noStrike">
                <a:solidFill>
                  <a:srgbClr val="000000"/>
                </a:solidFill>
                <a:latin typeface="Calibri"/>
                <a:ea typeface="Arial"/>
              </a:rPr>
              <a:t> in dying stroke patients after transferral to Intensive Care Unit (n=22)</a:t>
            </a:r>
            <a:r>
              <a:rPr b="1" lang="de-DE" sz="11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05T13:00:37Z</dcterms:created>
  <dc:creator>Alonso, Angelika</dc:creator>
  <dc:description/>
  <dc:language>en-US</dc:language>
  <cp:lastModifiedBy>Alonso, Angelika</cp:lastModifiedBy>
  <dcterms:modified xsi:type="dcterms:W3CDTF">2016-04-01T12:50:08Z</dcterms:modified>
  <cp:revision>8</cp:revision>
  <dc:subject/>
  <dc:title>PowerPoint-Präsentation</dc:title>
</cp:coreProperties>
</file>